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bg-BG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9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5F75BF2-F436-4F6F-9D9C-B4AA495A8A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bg-BG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034A0FD4-3594-426B-9D55-DB5B6C4292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bg-B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68F9760-7584-4ADC-8F4D-E87B00F1D6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6164689-D709-465C-AD23-94EA2613A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bg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1DE5F23-BE97-4617-B646-234A5E895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87456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F429CE7-A25E-4112-BFBB-61BB6ACD39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bg-B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324C0E4C-E737-4678-B19B-C86ACD4B3D2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bg-B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2827C72-ABAA-4338-AD93-9B8EBC89EC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50B5355-BCCE-4716-9B58-36B7FB638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bg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E42785B-3E5C-4AF6-98C4-FF3E254B24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10113804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4C8FAF39-1B76-4BF1-9734-A3444A7039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bg-BG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D8A8833-3297-4615-BB00-1A669D866E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bg-B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D577DE1-6FA8-41B3-8D2A-A13038757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F8F2F07-BD4D-4387-9C78-9A2E1018DC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bg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697D6A5-938C-4DE6-81FF-F3F6846B3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33752483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699084E-5856-4E84-B160-00386CD76E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bg-B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FDEB963-7F04-4292-B1B2-7063AE3AD1F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bg-B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41D9970-B0BD-4A12-9251-0670015D52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C102C3F-2217-48CB-AC27-E4256F5CB6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bg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B79EAF3-F872-4306-AD44-AD549750D2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2506528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2014463-7751-42BB-944E-85BF0F6674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bg-B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12F916C-36FD-42DA-AEA8-6F506C8C00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D791D7E-22C0-436A-AD20-7DD9D6C5F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E72162A-091F-4A6C-BF7F-1768015225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bg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9FB67C3-5FB9-430F-9E73-26303B333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3267401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AE7012E-1139-47D1-A2C6-EA3304102F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bg-B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68AB6E5-2FCF-4EB0-9A32-06CE27E7505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bg-BG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43794B89-EB6A-4BC5-ABF8-0B87AB5BC1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bg-BG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785A124-2788-4352-805D-6F1D8C850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F6AC1F3C-DBB3-42A6-A6FE-00ACB70CB3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bg-B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2B2F709-CB2B-49D5-BC97-E1DAD15D3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17373207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1DCBD7F-5BA8-4A28-BED9-747F9D35A2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bg-B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FBF6465-2DA0-4815-B79E-EB753232DC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F628173-E60D-4B49-89B6-857270099B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bg-BG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C148726F-39D3-43D7-A515-52EC1CBF9F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2C51EA7B-1E06-40FF-922B-A917CC41A8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bg-BG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B1490159-13CB-4246-A602-258B1425B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6B3EFD08-B4C1-426E-BEB6-E6491896C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bg-BG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74893D36-B6E2-41D7-8C2E-DE2D56DECB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279043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255C31B-8415-472D-8DA1-271626AB72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bg-BG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CD57483D-9829-43B8-926B-2D97083C77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DC4B39FE-786A-419C-A094-3C37D1D78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bg-BG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2B1C1F0C-D250-4B37-B336-113A7728F1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1927982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1F57C1EF-FEFA-4063-B3FB-6DBC2C6B9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D6FDE051-55FC-42E8-B7AE-C3D1EE5C5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bg-BG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03FF4917-A40B-4607-B788-58DEDCACD0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3583612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25DF2E0-756D-4734-B226-74563CA797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bg-BG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576FF61-8E9B-43FF-88AA-85ED3B8169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bg-B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250D3DB-CD91-4D6D-B28A-DECBEAC9F6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E4683387-DE7A-4AFC-8C09-525263616C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113CA54-C16E-4EBC-9700-FB511454E7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bg-B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AD657AE-9314-445F-B95B-717E27CB3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167241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4482E7F-6A50-471B-BEA3-214047F693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bg-BG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FCEB6C13-CCE6-4AD6-B747-B1FC909A50B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bg-BG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BE736851-53B4-4EAB-B0A9-5E8227C9E8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7AC63B57-F118-4E09-85A8-753B34FCDC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45CEF0C-FFC7-4D6F-BA3B-67741069A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bg-BG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553A022-D67D-47A5-948C-4177E12434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3687446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349C1A91-1880-4EF3-9FB8-1F8D6746E0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bg-BG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BF53298-7F38-46B0-A1C5-CEB098908B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bg-BG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8A267CA-258E-422E-A0A6-ABC2539CDD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5C351-5069-40E7-A711-BD0BAEFBFF66}" type="datetimeFigureOut">
              <a:rPr lang="bg-BG" smtClean="0"/>
              <a:t>7.12.2021 г.</a:t>
            </a:fld>
            <a:endParaRPr lang="bg-BG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4D9C44C-A6A2-4249-ADFB-BA0DC9D2A3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bg-BG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3666E2F-6CB8-47C5-A15B-E6FAFE3515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93BD5-C71A-4EF0-9617-8FC4F9B463A3}" type="slidenum">
              <a:rPr lang="bg-BG" smtClean="0"/>
              <a:t>‹#›</a:t>
            </a:fld>
            <a:endParaRPr lang="bg-BG"/>
          </a:p>
        </p:txBody>
      </p:sp>
    </p:spTree>
    <p:extLst>
      <p:ext uri="{BB962C8B-B14F-4D97-AF65-F5344CB8AC3E}">
        <p14:creationId xmlns:p14="http://schemas.microsoft.com/office/powerpoint/2010/main" val="19630540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bg-BG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>
            <a:extLst>
              <a:ext uri="{FF2B5EF4-FFF2-40B4-BE49-F238E27FC236}">
                <a16:creationId xmlns:a16="http://schemas.microsoft.com/office/drawing/2014/main" xmlns="" id="{98F9A6B8-E381-49F2-8F9B-081667226764}"/>
              </a:ext>
            </a:extLst>
          </p:cNvPr>
          <p:cNvGrpSpPr/>
          <p:nvPr/>
        </p:nvGrpSpPr>
        <p:grpSpPr>
          <a:xfrm>
            <a:off x="394822" y="-7949"/>
            <a:ext cx="11357864" cy="6046799"/>
            <a:chOff x="394822" y="-7949"/>
            <a:chExt cx="11262812" cy="7018349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xmlns="" id="{0FD0E925-10C3-4C4B-A6C2-9A11F8C39834}"/>
                </a:ext>
              </a:extLst>
            </p:cNvPr>
            <p:cNvGrpSpPr/>
            <p:nvPr/>
          </p:nvGrpSpPr>
          <p:grpSpPr>
            <a:xfrm>
              <a:off x="945492" y="205945"/>
              <a:ext cx="10712142" cy="6804455"/>
              <a:chOff x="118891" y="113796"/>
              <a:chExt cx="10712142" cy="6804455"/>
            </a:xfrm>
          </p:grpSpPr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xmlns="" id="{7D0A1469-B364-44ED-9D5C-DE1DF74F0FC0}"/>
                  </a:ext>
                </a:extLst>
              </p:cNvPr>
              <p:cNvGrpSpPr/>
              <p:nvPr/>
            </p:nvGrpSpPr>
            <p:grpSpPr>
              <a:xfrm>
                <a:off x="118891" y="113796"/>
                <a:ext cx="3440097" cy="6744204"/>
                <a:chOff x="118891" y="113796"/>
                <a:chExt cx="3135667" cy="6361541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xmlns="" id="{42104338-FEDD-49A0-AFE8-CF34EF92A4A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118891" y="2214468"/>
                  <a:ext cx="3134699" cy="2160197"/>
                </a:xfrm>
                <a:prstGeom prst="rect">
                  <a:avLst/>
                </a:prstGeom>
              </p:spPr>
            </p:pic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xmlns="" id="{21129B13-BFF3-4351-9B6A-3FDDC2F89A9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36821" y="113796"/>
                  <a:ext cx="3115901" cy="2160197"/>
                </a:xfrm>
                <a:prstGeom prst="rect">
                  <a:avLst/>
                </a:prstGeom>
              </p:spPr>
            </p:pic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xmlns="" id="{9C5C7F7B-EA2F-4417-89F5-EC7BDB394B4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154751" y="4315140"/>
                  <a:ext cx="3099807" cy="2160197"/>
                </a:xfrm>
                <a:prstGeom prst="rect">
                  <a:avLst/>
                </a:prstGeom>
              </p:spPr>
            </p:pic>
          </p:grpSp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xmlns="" id="{230527A4-7644-40E1-A658-98C4BA2FBCE8}"/>
                  </a:ext>
                </a:extLst>
              </p:cNvPr>
              <p:cNvGrpSpPr/>
              <p:nvPr/>
            </p:nvGrpSpPr>
            <p:grpSpPr>
              <a:xfrm>
                <a:off x="3656114" y="117835"/>
                <a:ext cx="3518139" cy="6800416"/>
                <a:chOff x="3735018" y="117835"/>
                <a:chExt cx="3140804" cy="6455295"/>
              </a:xfrm>
            </p:grpSpPr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xmlns="" id="{7188CB1F-919D-4E7F-B878-38F59010657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3735018" y="2254195"/>
                  <a:ext cx="3112477" cy="2173229"/>
                </a:xfrm>
                <a:prstGeom prst="rect">
                  <a:avLst/>
                </a:prstGeom>
              </p:spPr>
            </p:pic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xmlns="" id="{8B98A707-12D3-4A2C-96A4-80C4837EE4F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3735018" y="117835"/>
                  <a:ext cx="3112477" cy="2163884"/>
                </a:xfrm>
                <a:prstGeom prst="rect">
                  <a:avLst/>
                </a:prstGeom>
              </p:spPr>
            </p:pic>
            <p:pic>
              <p:nvPicPr>
                <p:cNvPr id="15" name="Picture 14">
                  <a:extLst>
                    <a:ext uri="{FF2B5EF4-FFF2-40B4-BE49-F238E27FC236}">
                      <a16:creationId xmlns:a16="http://schemas.microsoft.com/office/drawing/2014/main" xmlns="" id="{A656ACEC-5580-4CBC-90AC-BDEB79A4E8F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3735018" y="4399901"/>
                  <a:ext cx="3140804" cy="2173229"/>
                </a:xfrm>
                <a:prstGeom prst="rect">
                  <a:avLst/>
                </a:prstGeom>
              </p:spPr>
            </p:pic>
          </p:grp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xmlns="" id="{22BBF4D3-0810-4B16-B626-4E1EEFFBBD3B}"/>
                  </a:ext>
                </a:extLst>
              </p:cNvPr>
              <p:cNvGrpSpPr/>
              <p:nvPr/>
            </p:nvGrpSpPr>
            <p:grpSpPr>
              <a:xfrm>
                <a:off x="7271379" y="143438"/>
                <a:ext cx="3559654" cy="6774813"/>
                <a:chOff x="7271379" y="143438"/>
                <a:chExt cx="3236507" cy="6655683"/>
              </a:xfrm>
            </p:grpSpPr>
            <p:pic>
              <p:nvPicPr>
                <p:cNvPr id="19" name="Picture 18">
                  <a:extLst>
                    <a:ext uri="{FF2B5EF4-FFF2-40B4-BE49-F238E27FC236}">
                      <a16:creationId xmlns:a16="http://schemas.microsoft.com/office/drawing/2014/main" xmlns="" id="{79EE30CF-EC60-4DF0-B20C-BF5420DB1DF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7271379" y="2333609"/>
                  <a:ext cx="3233895" cy="2255258"/>
                </a:xfrm>
                <a:prstGeom prst="rect">
                  <a:avLst/>
                </a:prstGeom>
              </p:spPr>
            </p:pic>
            <p:pic>
              <p:nvPicPr>
                <p:cNvPr id="21" name="Picture 20">
                  <a:extLst>
                    <a:ext uri="{FF2B5EF4-FFF2-40B4-BE49-F238E27FC236}">
                      <a16:creationId xmlns:a16="http://schemas.microsoft.com/office/drawing/2014/main" xmlns="" id="{CEB8ED81-5922-4CAE-8E80-7F2AA345478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7271379" y="143438"/>
                  <a:ext cx="3217327" cy="2216798"/>
                </a:xfrm>
                <a:prstGeom prst="rect">
                  <a:avLst/>
                </a:prstGeom>
              </p:spPr>
            </p:pic>
            <p:pic>
              <p:nvPicPr>
                <p:cNvPr id="23" name="Picture 22">
                  <a:extLst>
                    <a:ext uri="{FF2B5EF4-FFF2-40B4-BE49-F238E27FC236}">
                      <a16:creationId xmlns:a16="http://schemas.microsoft.com/office/drawing/2014/main" xmlns="" id="{6B87D8F5-160C-43CC-88F2-A6D380A4797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/>
                <a:stretch>
                  <a:fillRect/>
                </a:stretch>
              </p:blipFill>
              <p:spPr>
                <a:xfrm>
                  <a:off x="7273991" y="4550407"/>
                  <a:ext cx="3233895" cy="2248714"/>
                </a:xfrm>
                <a:prstGeom prst="rect">
                  <a:avLst/>
                </a:prstGeom>
              </p:spPr>
            </p:pic>
          </p:grp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xmlns="" id="{F19917CC-9EA9-47BF-AB5B-D61361534B3B}"/>
                </a:ext>
              </a:extLst>
            </p:cNvPr>
            <p:cNvSpPr txBox="1"/>
            <p:nvPr/>
          </p:nvSpPr>
          <p:spPr>
            <a:xfrm>
              <a:off x="1887634" y="-7949"/>
              <a:ext cx="1676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DS specific DEGs</a:t>
              </a:r>
              <a:endParaRPr lang="bg-BG" sz="1400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xmlns="" id="{61012DBA-097E-4A80-B1F4-EBE7F05F962E}"/>
                </a:ext>
              </a:extLst>
            </p:cNvPr>
            <p:cNvSpPr txBox="1"/>
            <p:nvPr/>
          </p:nvSpPr>
          <p:spPr>
            <a:xfrm>
              <a:off x="5519561" y="-2283"/>
              <a:ext cx="1676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KK specific DEGs</a:t>
              </a:r>
              <a:endParaRPr lang="bg-BG" sz="1400" dirty="0"/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xmlns="" id="{813E7F3F-89BE-442F-BC71-1CDEBD0124B1}"/>
                </a:ext>
              </a:extLst>
            </p:cNvPr>
            <p:cNvSpPr txBox="1"/>
            <p:nvPr/>
          </p:nvSpPr>
          <p:spPr>
            <a:xfrm>
              <a:off x="9151487" y="0"/>
              <a:ext cx="16764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Overlapping DEGs</a:t>
              </a:r>
              <a:endParaRPr lang="bg-BG" sz="1400" dirty="0"/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xmlns="" id="{B30EF2EE-4A66-4A61-AABB-93CA8A5D5CB6}"/>
                </a:ext>
              </a:extLst>
            </p:cNvPr>
            <p:cNvSpPr txBox="1"/>
            <p:nvPr/>
          </p:nvSpPr>
          <p:spPr>
            <a:xfrm>
              <a:off x="394822" y="1093017"/>
              <a:ext cx="7230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GO:MF</a:t>
              </a:r>
              <a:endParaRPr lang="bg-BG" sz="1400" dirty="0"/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xmlns="" id="{5F7939A1-89EF-49B8-ACC8-F16DD447A09B}"/>
                </a:ext>
              </a:extLst>
            </p:cNvPr>
            <p:cNvSpPr txBox="1"/>
            <p:nvPr/>
          </p:nvSpPr>
          <p:spPr>
            <a:xfrm>
              <a:off x="394822" y="3397445"/>
              <a:ext cx="7230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GO:BP</a:t>
              </a:r>
              <a:endParaRPr lang="bg-BG" sz="1400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xmlns="" id="{CDE9B43C-75D4-4E57-A1CC-4418093070C9}"/>
                </a:ext>
              </a:extLst>
            </p:cNvPr>
            <p:cNvSpPr txBox="1"/>
            <p:nvPr/>
          </p:nvSpPr>
          <p:spPr>
            <a:xfrm>
              <a:off x="394822" y="5701873"/>
              <a:ext cx="72301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GO:CC</a:t>
              </a:r>
              <a:endParaRPr lang="bg-BG" sz="1400" dirty="0"/>
            </a:p>
          </p:txBody>
        </p:sp>
      </p:grp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D76F818E-C6BA-491C-B9CC-5DF18529B7CA}"/>
              </a:ext>
            </a:extLst>
          </p:cNvPr>
          <p:cNvSpPr txBox="1"/>
          <p:nvPr/>
        </p:nvSpPr>
        <p:spPr>
          <a:xfrm>
            <a:off x="834136" y="5635004"/>
            <a:ext cx="11357864" cy="12618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endParaRPr lang="bg-BG" sz="2000" b="0" i="0" u="none" strike="noStrike" baseline="0" dirty="0">
              <a:solidFill>
                <a:srgbClr val="000000"/>
              </a:solidFill>
              <a:latin typeface="Times New Roman" panose="02020603050405020304" pitchFamily="18" charset="0"/>
            </a:endParaRPr>
          </a:p>
          <a:p>
            <a:r>
              <a:rPr lang="en-US" sz="2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sz="1800" b="1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sz="1800" b="1" i="0" u="none" strike="noStrike" baseline="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S3. </a:t>
            </a:r>
            <a:r>
              <a:rPr lang="en-US" sz="1800" b="0" i="0" u="none" strike="noStrike" baseline="0" dirty="0">
                <a:solidFill>
                  <a:srgbClr val="000000"/>
                </a:solidFill>
                <a:latin typeface="Calibri" panose="020F0502020204030204" pitchFamily="34" charset="0"/>
              </a:rPr>
              <a:t>Gene Ontology scatterplot constructed by REVIGO. The x-axis showed the p-value of log10 of each GO term after REVIGO analysis, while the y-axis exhibited the logarithmic size of the GO term frequency in the GO annotation database. </a:t>
            </a:r>
            <a:endParaRPr lang="bg-BG" dirty="0"/>
          </a:p>
        </p:txBody>
      </p:sp>
    </p:spTree>
    <p:extLst>
      <p:ext uri="{BB962C8B-B14F-4D97-AF65-F5344CB8AC3E}">
        <p14:creationId xmlns:p14="http://schemas.microsoft.com/office/powerpoint/2010/main" val="3056537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5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yana Gozmanova</dc:creator>
  <cp:lastModifiedBy>MDPI</cp:lastModifiedBy>
  <cp:revision>2</cp:revision>
  <dcterms:created xsi:type="dcterms:W3CDTF">2021-11-11T11:53:03Z</dcterms:created>
  <dcterms:modified xsi:type="dcterms:W3CDTF">2021-12-07T11:08:27Z</dcterms:modified>
</cp:coreProperties>
</file>